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323" r:id="rId5"/>
  </p:sldIdLst>
  <p:sldSz cx="6858000" cy="9144000" type="screen4x3"/>
  <p:notesSz cx="674211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9D49F-AA6E-9F21-FC37-C929F14AF95C}" name="吳建甫" initials="吳建甫" userId="S::chienfuwu@smail.nchu.edu.tw::c5775c99-bbf3-4fcb-9699-18d78189bfe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0511"/>
    <a:srgbClr val="3C576E"/>
    <a:srgbClr val="04AC44"/>
    <a:srgbClr val="3333FF"/>
    <a:srgbClr val="FFFFFF"/>
    <a:srgbClr val="00B050"/>
    <a:srgbClr val="BBE0E3"/>
    <a:srgbClr val="FF0080"/>
    <a:srgbClr val="333399"/>
    <a:srgbClr val="82C7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69" autoAdjust="0"/>
    <p:restoredTop sz="94469" autoAdjust="0"/>
  </p:normalViewPr>
  <p:slideViewPr>
    <p:cSldViewPr>
      <p:cViewPr varScale="1">
        <p:scale>
          <a:sx n="82" d="100"/>
          <a:sy n="82" d="100"/>
        </p:scale>
        <p:origin x="3584" y="168"/>
      </p:cViewPr>
      <p:guideLst>
        <p:guide orient="horz" pos="2880"/>
        <p:guide pos="2160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0405E8D-78BA-46CE-9351-BD3F0736071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863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4" name="Rectangle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982788" y="739775"/>
            <a:ext cx="2776537" cy="37036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024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949" y="4689515"/>
            <a:ext cx="4944216" cy="4442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9FFBD4F-9474-4780-8DBA-462E29ED7B0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55180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7AFA02-3A71-4EDC-B423-667874068FBD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64026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54E27CC-85E4-4496-A7F0-2E2670B20B92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25119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CFFD98-9F5D-46B8-9754-C6A950F5FA7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684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A7A8B3-9053-45B9-B735-E224EA3F700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218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FE32FF-88FC-474E-996B-A94BCDED645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50054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555867D-8AAE-4A66-A076-18178580007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5811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B8ACE5-1135-4BE0-B388-161C50BEDD8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11245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FCAD62-6D3F-45DC-B872-ADA7E085D82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9035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0ACF794-06F2-4293-9454-C61DD4CFF7E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4222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132D4C-4246-4204-BA16-7119E5B05E5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6015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310D11-78E9-40A8-AAC3-BBB7F94918BA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139541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2E051F03-9376-418F-B588-D0E7AFEFCA5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BD2ACCA-4AA0-50DF-2B73-1175E3AF83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1435748"/>
              </p:ext>
            </p:extLst>
          </p:nvPr>
        </p:nvGraphicFramePr>
        <p:xfrm>
          <a:off x="764704" y="251520"/>
          <a:ext cx="5328592" cy="774700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296144">
                  <a:extLst>
                    <a:ext uri="{9D8B030D-6E8A-4147-A177-3AD203B41FA5}">
                      <a16:colId xmlns:a16="http://schemas.microsoft.com/office/drawing/2014/main" val="1279134159"/>
                    </a:ext>
                  </a:extLst>
                </a:gridCol>
                <a:gridCol w="4032448">
                  <a:extLst>
                    <a:ext uri="{9D8B030D-6E8A-4147-A177-3AD203B41FA5}">
                      <a16:colId xmlns:a16="http://schemas.microsoft.com/office/drawing/2014/main" val="1337910246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l"/>
                      <a:r>
                        <a:rPr lang="en-US" altLang="zh-TW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Table S3. </a:t>
                      </a:r>
                      <a:r>
                        <a:rPr lang="en-US" altLang="zh-TW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umber or amino acid sequence of </a:t>
                      </a:r>
                      <a:r>
                        <a:rPr lang="en-US" altLang="zh-TW" sz="12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icted</a:t>
                      </a:r>
                      <a:r>
                        <a:rPr lang="en-US" altLang="zh-TW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otential CP-encoding</a:t>
                      </a:r>
                      <a:r>
                        <a:rPr lang="zh-TW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TW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Fs</a:t>
                      </a:r>
                      <a:r>
                        <a:rPr lang="zh-TW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TW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zh-TW" alt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TW" sz="12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taflexiviruses</a:t>
                      </a:r>
                      <a:r>
                        <a:rPr lang="en-US" altLang="zh-TW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FDFV2-related viruses.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97385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b="1" dirty="0"/>
                        <a:t>Virus </a:t>
                      </a:r>
                      <a:endParaRPr lang="zh-TW" altLang="en-US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b="1" dirty="0"/>
                        <a:t>Accession No. or amino acid sequence</a:t>
                      </a:r>
                      <a:endParaRPr lang="zh-TW" altLang="en-US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50644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 err="1">
                          <a:latin typeface="+mj-lt"/>
                        </a:rPr>
                        <a:t>CfaDFV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CAH2618743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66451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At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QG34635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3901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Ena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KN22723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4506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EnaDFV4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KN22696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69053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zh-TW" sz="12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EnaDFV2</a:t>
                      </a:r>
                      <a:endParaRPr kumimoji="1" lang="zh-TW" altLang="en-US" sz="12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KN22648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0463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S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QG34643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07867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Aa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TZ98078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10194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As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QQG34630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61558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Fg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YP_009268713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39291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SlaM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YP_009508375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235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Ss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YP_009508364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53040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PoDFV1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WCU24519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58442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AfDFV1</a:t>
                      </a:r>
                      <a:r>
                        <a:rPr lang="en-US" altLang="zh-TW" sz="1200" baseline="30000" dirty="0">
                          <a:latin typeface="+mj-lt"/>
                        </a:rPr>
                        <a:t>*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TW" sz="1200" dirty="0">
                          <a:latin typeface="+mj-lt"/>
                        </a:rPr>
                        <a:t>MSDLVGDTAHLHRRTIPFKIAYTLSGAEGHGHFAIPTANGFKQLAASRASVRIVSDSLRCQVLGPASPSVALEAYVAIVPKDLESWPTKPAQLLTIGGSCYCQHSIYSPSRTVPIEFSAEAAHQIKPTPLVGSAPEVVYYFQAVGGETTTTSYLCLSGLIEVDGIGFTQTW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52254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j-lt"/>
                        </a:rPr>
                        <a:t>EnaDFV3</a:t>
                      </a:r>
                      <a:r>
                        <a:rPr lang="en-US" altLang="zh-TW" sz="1200" baseline="30000" dirty="0">
                          <a:latin typeface="+mj-lt"/>
                        </a:rPr>
                        <a:t>*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TW" sz="1200" dirty="0">
                          <a:latin typeface="+mj-lt"/>
                        </a:rPr>
                        <a:t>MAISATDAQLPALTSGVSTLEVATPSLPREIEIPFVQMFQPGTTKQLSWTSGDIKTMMAPYESVKFVSLAFSVEVTGQTGKLQFAAVTDSDGPASEDDWFGATVFQRFSGNAHGDTYAEYSFPARHPFGLELKAVTLGNDPPYFFFRFKGSTGNSAAIRGKLVIRGGGHGIIPAHRLTDITPKA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3370234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 algn="l"/>
                      <a:r>
                        <a:rPr lang="en-US" altLang="zh-TW" sz="1200" dirty="0">
                          <a:latin typeface="+mj-lt"/>
                        </a:rPr>
                        <a:t>*: Potential CP-encoding ORF doesn’t indicate in </a:t>
                      </a:r>
                      <a:r>
                        <a:rPr lang="en-US" altLang="zh-TW" sz="1200" dirty="0" err="1">
                          <a:latin typeface="+mj-lt"/>
                        </a:rPr>
                        <a:t>Genbank</a:t>
                      </a:r>
                      <a:r>
                        <a:rPr lang="en-US" altLang="zh-TW" sz="1200" dirty="0">
                          <a:latin typeface="+mj-lt"/>
                        </a:rPr>
                        <a:t>, but we identified in this study using  ORF finder.</a:t>
                      </a:r>
                      <a:endParaRPr lang="zh-TW" altLang="en-US" sz="1200" dirty="0">
                        <a:latin typeface="+mj-lt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sz="1200" dirty="0">
                        <a:latin typeface="+mj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36188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0219788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文件" ma:contentTypeID="0x0101007E2FD972D4BEA54BA4598308043A68E5" ma:contentTypeVersion="15" ma:contentTypeDescription="建立新的文件。" ma:contentTypeScope="" ma:versionID="a8220bdea2b7e7a673e49e11bde4d37a">
  <xsd:schema xmlns:xsd="http://www.w3.org/2001/XMLSchema" xmlns:xs="http://www.w3.org/2001/XMLSchema" xmlns:p="http://schemas.microsoft.com/office/2006/metadata/properties" xmlns:ns3="48771fd5-fdbd-41d5-a635-61c877e51ed8" targetNamespace="http://schemas.microsoft.com/office/2006/metadata/properties" ma:root="true" ma:fieldsID="43f6d274064a590dd4c7dc18eb5ad241" ns3:_="">
    <xsd:import namespace="48771fd5-fdbd-41d5-a635-61c877e51ed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771fd5-fdbd-41d5-a635-61c877e51e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內容類型"/>
        <xsd:element ref="dc:title" minOccurs="0" maxOccurs="1" ma:index="4" ma:displayName="標題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8771fd5-fdbd-41d5-a635-61c877e51ed8" xsi:nil="true"/>
  </documentManagement>
</p:properties>
</file>

<file path=customXml/itemProps1.xml><?xml version="1.0" encoding="utf-8"?>
<ds:datastoreItem xmlns:ds="http://schemas.openxmlformats.org/officeDocument/2006/customXml" ds:itemID="{FBB41457-EEA7-4D1C-80C7-C64600237B1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7D4AA48-083E-4379-89A1-F75D79A20F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771fd5-fdbd-41d5-a635-61c877e51e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0A4D93D-CB7A-4046-B8F0-734EB4DA984F}">
  <ds:schemaRefs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48771fd5-fdbd-41d5-a635-61c877e51ed8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459</TotalTime>
  <Words>84</Words>
  <Application>Microsoft Macintosh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新しいプレゼンテーション</vt:lpstr>
      <vt:lpstr>PowerPoint プレゼンテーション</vt:lpstr>
    </vt:vector>
  </TitlesOfParts>
  <Company>青木 菜々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template</dc:title>
  <dc:creator>Chien-Fu Wu</dc:creator>
  <cp:lastModifiedBy>KOMATSU Ken</cp:lastModifiedBy>
  <cp:revision>1151</cp:revision>
  <cp:lastPrinted>2021-04-12T04:03:22Z</cp:lastPrinted>
  <dcterms:created xsi:type="dcterms:W3CDTF">2010-08-07T07:11:10Z</dcterms:created>
  <dcterms:modified xsi:type="dcterms:W3CDTF">2024-10-29T08:20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E2FD972D4BEA54BA4598308043A68E5</vt:lpwstr>
  </property>
</Properties>
</file>